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99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65" userDrawn="1">
          <p15:clr>
            <a:srgbClr val="A4A3A4"/>
          </p15:clr>
        </p15:guide>
        <p15:guide id="2" pos="31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00" autoAdjust="0"/>
    <p:restoredTop sz="94643" autoAdjust="0"/>
  </p:normalViewPr>
  <p:slideViewPr>
    <p:cSldViewPr snapToGrid="0">
      <p:cViewPr varScale="1">
        <p:scale>
          <a:sx n="97" d="100"/>
          <a:sy n="97" d="100"/>
        </p:scale>
        <p:origin x="1458" y="84"/>
      </p:cViewPr>
      <p:guideLst>
        <p:guide orient="horz" pos="1865"/>
        <p:guide pos="316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Ohi-fsi\voli\Home\LARG\MCPHERSON\Sebastien\Results%202019\APRIL%2023%202019%20SEB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P$10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S$101:$T$101</c:f>
                <c:numCache>
                  <c:formatCode>General</c:formatCode>
                  <c:ptCount val="2"/>
                  <c:pt idx="0">
                    <c:v>0.63255210956687757</c:v>
                  </c:pt>
                  <c:pt idx="1">
                    <c:v>0.68071782832957795</c:v>
                  </c:pt>
                </c:numCache>
              </c:numRef>
            </c:plus>
            <c:minus>
              <c:numRef>
                <c:f>Sheet1!$S$101:$T$101</c:f>
                <c:numCache>
                  <c:formatCode>General</c:formatCode>
                  <c:ptCount val="2"/>
                  <c:pt idx="0">
                    <c:v>0.63255210956687757</c:v>
                  </c:pt>
                  <c:pt idx="1">
                    <c:v>0.680717828329577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Q$100:$R$100</c:f>
              <c:strCache>
                <c:ptCount val="2"/>
                <c:pt idx="0">
                  <c:v>RP11</c:v>
                </c:pt>
                <c:pt idx="1">
                  <c:v>IL6</c:v>
                </c:pt>
              </c:strCache>
            </c:strRef>
          </c:cat>
          <c:val>
            <c:numRef>
              <c:f>Sheet1!$Q$101:$R$101</c:f>
              <c:numCache>
                <c:formatCode>General</c:formatCode>
                <c:ptCount val="2"/>
                <c:pt idx="0" formatCode="0.00E+00">
                  <c:v>6.0575304694459131</c:v>
                </c:pt>
                <c:pt idx="1">
                  <c:v>3.24750244050117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6C-4B23-9F81-472946B2E9D3}"/>
            </c:ext>
          </c:extLst>
        </c:ser>
        <c:ser>
          <c:idx val="1"/>
          <c:order val="1"/>
          <c:tx>
            <c:strRef>
              <c:f>Sheet1!$P$102</c:f>
              <c:strCache>
                <c:ptCount val="1"/>
                <c:pt idx="0">
                  <c:v>ΔSG-505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S$102:$T$102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99880321189186638</c:v>
                  </c:pt>
                </c:numCache>
              </c:numRef>
            </c:plus>
            <c:minus>
              <c:numRef>
                <c:f>Sheet1!$S$102:$T$102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998803211891866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Q$100:$R$100</c:f>
              <c:strCache>
                <c:ptCount val="2"/>
                <c:pt idx="0">
                  <c:v>RP11</c:v>
                </c:pt>
                <c:pt idx="1">
                  <c:v>IL6</c:v>
                </c:pt>
              </c:strCache>
            </c:strRef>
          </c:cat>
          <c:val>
            <c:numRef>
              <c:f>Sheet1!$Q$102:$R$102</c:f>
              <c:numCache>
                <c:formatCode>General</c:formatCode>
                <c:ptCount val="2"/>
                <c:pt idx="0" formatCode="0.00E+00">
                  <c:v>0.94217687074829926</c:v>
                </c:pt>
                <c:pt idx="1">
                  <c:v>3.19564068093136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96C-4B23-9F81-472946B2E9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88016240"/>
        <c:axId val="688016568"/>
      </c:barChart>
      <c:catAx>
        <c:axId val="6880162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88016568"/>
        <c:crosses val="autoZero"/>
        <c:auto val="1"/>
        <c:lblAlgn val="ctr"/>
        <c:lblOffset val="100"/>
        <c:noMultiLvlLbl val="0"/>
      </c:catAx>
      <c:valAx>
        <c:axId val="688016568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880162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871889645794422"/>
          <c:y val="4.7893246017515136E-2"/>
          <c:w val="0.42246885525462458"/>
          <c:h val="0.1040700520220930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smtClean="0"/>
            </a:lvl1pPr>
          </a:lstStyle>
          <a:p>
            <a:pPr>
              <a:defRPr/>
            </a:pPr>
            <a:fld id="{1C9D0A36-DE4C-4440-8F6C-AEF2CA54FF85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 smtClean="0"/>
            </a:lvl1pPr>
          </a:lstStyle>
          <a:p>
            <a:pPr>
              <a:defRPr/>
            </a:pPr>
            <a:fld id="{A95C0E93-8D30-4A30-9328-4E0FB45E5B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58131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A5558D-8F49-48AC-9AD1-376CB1A7E39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4AB339-7594-4B22-A554-7B400AD98A7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87302B-CA7A-4E6B-A47F-DC332C23FD1A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B45D9B-561E-4F88-9AB5-8E4B827DF60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3E4499-94DD-4CAD-8E21-EA1AF54156B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1531EF-E7B4-422A-88BB-47B0975638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5F7945-BBD4-4978-87EC-C7D80B463AB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82FDBD-73E8-482B-8B0A-795AAB09BF7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D2AAE2-0E64-4293-B29A-F50BD23856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6B7EBA-6E88-45F3-AFA7-7E4748CF9C5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A8DA1D-4DE8-42BC-BD9E-CD5459035D5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6093AD-FB35-44EB-A78B-A8D57029FF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262641-2E0D-4F47-A695-B40F164E5298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51291B-6319-4CBE-8716-8CDE732F976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FDA3E8-4DC9-49DD-84E5-CA89B17ADDB1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D8FBAA-AA12-4A4C-97FB-28969739D87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30EB80-9B42-4E8C-93AE-BFC21D3B5E8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D0E515-5FC4-4574-A5BE-D608BFDDD9D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B70ED7-D082-44C4-A6ED-5DA8752B74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DAFEFA-4281-4F12-A99A-44E264AE90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59D499-0483-4786-8C94-B4A7588B087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57DE42-43C2-45E9-BD3A-849BD950B3A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A6D2247-3288-4C0A-8C55-B2B65727C759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234A502B-99B5-4993-AC5A-918CFA4C90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2175138"/>
              </p:ext>
            </p:extLst>
          </p:nvPr>
        </p:nvGraphicFramePr>
        <p:xfrm>
          <a:off x="3243474" y="1293208"/>
          <a:ext cx="2518001" cy="3848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45951" y="4678077"/>
            <a:ext cx="882185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 Fig.  CRISPR targeting of the cognate SG</a:t>
            </a:r>
            <a:r>
              <a:rPr lang="en-CA" sz="14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505</a:t>
            </a:r>
            <a:r>
              <a:rPr lang="en-CA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inding site within the </a:t>
            </a:r>
            <a:r>
              <a:rPr lang="en-CA" sz="1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P11</a:t>
            </a:r>
            <a:r>
              <a:rPr lang="en-CA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prevents </a:t>
            </a:r>
            <a:r>
              <a:rPr lang="en-CA" sz="1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P11</a:t>
            </a:r>
            <a:r>
              <a:rPr lang="en-CA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ut not</a:t>
            </a:r>
            <a:r>
              <a:rPr lang="en-CA" sz="1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L6 </a:t>
            </a:r>
            <a:r>
              <a:rPr lang="en-CA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pregulation by </a:t>
            </a:r>
            <a:r>
              <a:rPr lang="en-CA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ISPRa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Top, CRISPR 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iting of the SG-505 recognition region.  DNA from 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putative 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nock-out clone was PCR amplified, </a:t>
            </a:r>
            <a:r>
              <a:rPr lang="en-CA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cloned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individual clones sent for validation by Sanger sequencing.  A total of 6 distinct 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 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that clone were obtained, conforming to 2 distinct patterns indicated above.  One allele 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ried point mutations (red) near 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-8 to -6)  the PAM site while the other allele exhibited a more extensive 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letion (</a:t>
            </a:r>
            <a:r>
              <a:rPr lang="en-CA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L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ulting sequences are expected to be poorly or not recognized by 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-505.  Bottom, 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ls harboring bi-allelic editing of SG</a:t>
            </a:r>
            <a:r>
              <a:rPr lang="en-CA" sz="14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505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inding site were transfected with </a:t>
            </a:r>
            <a:r>
              <a:rPr lang="en-CA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ISPRa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VPR) in the presence of either 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G</a:t>
            </a:r>
            <a:r>
              <a:rPr lang="en-CA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505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CA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crRNA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els of </a:t>
            </a:r>
            <a:r>
              <a:rPr lang="en-CA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P11 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CA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6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nd </a:t>
            </a:r>
            <a:r>
              <a:rPr lang="en-CA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PIA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re measured 48 h post-transfection.   Values are expressed relative to </a:t>
            </a:r>
            <a:r>
              <a:rPr lang="en-CA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PIA 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then normalized to the corresponding </a:t>
            </a:r>
            <a:r>
              <a:rPr lang="en-CA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crRNA</a:t>
            </a:r>
            <a:r>
              <a:rPr lang="en-CA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alues.  Data represent the average values obtained from 3 passages. </a:t>
            </a:r>
            <a:endParaRPr lang="en-CA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711039" y="2669920"/>
            <a:ext cx="41778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Relative expression </a:t>
            </a:r>
          </a:p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(normalized to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trcrRNA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2476790" y="292429"/>
            <a:ext cx="6754075" cy="12234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1200" dirty="0" smtClean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Wild-type: TGAACGG</a:t>
            </a:r>
            <a:r>
              <a:rPr lang="en-CA" sz="1200" u="sng" dirty="0" smtClean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GCTGTTCGGGGATAGCTG</a:t>
            </a:r>
            <a:r>
              <a:rPr lang="en-CA" sz="1200" dirty="0" smtClean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GGCTTGA</a:t>
            </a:r>
            <a:endParaRPr lang="en-CA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1200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llele 1: </a:t>
            </a:r>
            <a:r>
              <a:rPr lang="en-CA" sz="1200" dirty="0" smtClean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GAACGGAGCTGTTCGGG</a:t>
            </a:r>
            <a:r>
              <a:rPr lang="en-CA" sz="1200" dirty="0" smtClean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TG</a:t>
            </a:r>
            <a:r>
              <a:rPr lang="en-CA" sz="1200" dirty="0" smtClean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GCTGTGGCTTGA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Allele 2: TGAACGGAGCTGT</a:t>
            </a:r>
            <a:r>
              <a:rPr lang="en-CA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DEL</a:t>
            </a:r>
            <a:r>
              <a:rPr lang="en-CA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GGCTTGA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CA" sz="12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68893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31</TotalTime>
  <Words>202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ourier New</vt:lpstr>
      <vt:lpstr>Times New Roman</vt:lpstr>
      <vt:lpstr>Office Theme</vt:lpstr>
      <vt:lpstr>PowerPoint Presentation</vt:lpstr>
    </vt:vector>
  </TitlesOfParts>
  <Company>UOH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soubeyrand</dc:creator>
  <cp:lastModifiedBy>Sebastien Soubeyrand</cp:lastModifiedBy>
  <cp:revision>1210</cp:revision>
  <dcterms:created xsi:type="dcterms:W3CDTF">2017-11-23T16:07:42Z</dcterms:created>
  <dcterms:modified xsi:type="dcterms:W3CDTF">2019-10-09T12:48:33Z</dcterms:modified>
</cp:coreProperties>
</file>